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3"/>
    <p:restoredTop sz="96197"/>
  </p:normalViewPr>
  <p:slideViewPr>
    <p:cSldViewPr snapToGrid="0">
      <p:cViewPr varScale="1">
        <p:scale>
          <a:sx n="84" d="100"/>
          <a:sy n="84" d="100"/>
        </p:scale>
        <p:origin x="238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530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29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736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343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259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026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666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240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319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987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728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A90DFA-1590-C941-85F9-FDCD67B5CBF2}" type="datetimeFigureOut">
              <a:rPr lang="en-US" smtClean="0"/>
              <a:t>3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B64CB5-4233-6C43-9107-18E0FCE66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897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6561DFB-F710-CD2D-060F-C648C529D306}"/>
              </a:ext>
            </a:extLst>
          </p:cNvPr>
          <p:cNvSpPr txBox="1"/>
          <p:nvPr/>
        </p:nvSpPr>
        <p:spPr>
          <a:xfrm>
            <a:off x="-942109" y="6917857"/>
            <a:ext cx="6858000" cy="16183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158946" algn="just">
              <a:lnSpc>
                <a:spcPts val="1733"/>
              </a:lnSpc>
            </a:pP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1.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hibition of PAD catalyzed citrullination diminishes GnRHa induced β-actin reorganization in LβT2 cells. LβT2 cells were pre-treated for 12 hours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either vehicle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 1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B-</a:t>
            </a:r>
            <a:r>
              <a:rPr lang="en-US" sz="900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lA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Cells were serum starved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n stimulated with vehicle or 10 nM GnRHa for 10 minutes. Cells were examined by immunofluorescent confocal microscopy using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primary anti-β-actin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tibody, followed with an Alexa Fluor 594 secondary antibody (red) and stained with DAPI (blue). Cells were imaged using a Zeiss LSM 710 confocal microscope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 a 40X objective.</a:t>
            </a:r>
            <a:endParaRPr lang="en-US" sz="900" dirty="0">
              <a:solidFill>
                <a:srgbClr val="000000"/>
              </a:solidFill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Picture 6" descr="A collage of images of cells&#10;&#10;Description automatically generated">
            <a:extLst>
              <a:ext uri="{FF2B5EF4-FFF2-40B4-BE49-F238E27FC236}">
                <a16:creationId xmlns:a16="http://schemas.microsoft.com/office/drawing/2014/main" id="{9CFBF9A7-E140-9ACF-215D-9E9187C2BFE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495" t="10757" r="9697" b="19091"/>
          <a:stretch/>
        </p:blipFill>
        <p:spPr>
          <a:xfrm>
            <a:off x="658091" y="263236"/>
            <a:ext cx="5541818" cy="64146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8465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</TotalTime>
  <Words>9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ptos</vt:lpstr>
      <vt:lpstr>Aptos Display</vt:lpstr>
      <vt:lpstr>Arial</vt:lpstr>
      <vt:lpstr>Palatino Linotyp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Quigley</dc:creator>
  <cp:lastModifiedBy>Elizabeth Quigley</cp:lastModifiedBy>
  <cp:revision>5</cp:revision>
  <dcterms:created xsi:type="dcterms:W3CDTF">2024-01-29T17:40:18Z</dcterms:created>
  <dcterms:modified xsi:type="dcterms:W3CDTF">2024-03-09T18:49:06Z</dcterms:modified>
</cp:coreProperties>
</file>